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8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B57DEED-3C9F-254F-A3D8-E903F56A6D3F}">
          <p14:sldIdLst>
            <p14:sldId id="268"/>
          </p14:sldIdLst>
        </p14:section>
        <p14:section name="Untitled Section" id="{A74DD17C-FFF9-FB4F-8814-5BCAA9406279}">
          <p14:sldIdLst/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3800FF"/>
    <a:srgbClr val="D500D5"/>
    <a:srgbClr val="E8E8E8"/>
    <a:srgbClr val="FFFFFF"/>
    <a:srgbClr val="FFF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819" autoAdjust="0"/>
  </p:normalViewPr>
  <p:slideViewPr>
    <p:cSldViewPr snapToGrid="0" snapToObjects="1">
      <p:cViewPr>
        <p:scale>
          <a:sx n="68" d="100"/>
          <a:sy n="68" d="100"/>
        </p:scale>
        <p:origin x="-2352" y="-2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397439-2BE8-EC40-85D9-7D390B8117AE}" type="datetimeFigureOut">
              <a:rPr lang="en-US" smtClean="0"/>
              <a:pPr/>
              <a:t>10/06/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DE6B8A-FD7D-534A-B0EA-1620DC70E4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6929556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4CA3C-750D-B144-9A60-03636F5E942C}" type="datetimeFigureOut">
              <a:rPr lang="en-US" smtClean="0"/>
              <a:pPr/>
              <a:t>10/06/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068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E2BDAF-A836-E441-96EE-CD666C2510C6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875590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B35BD-36C8-2F48-A0A2-327C6062B363}" type="datetime1">
              <a:rPr lang="en-US" smtClean="0"/>
              <a:t>10/06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037A-2918-5643-8F90-F7F591C0219C}" type="datetime1">
              <a:rPr lang="en-US" smtClean="0"/>
              <a:t>10/06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E11DA-4CAF-9949-9B42-ADA6BE141461}" type="datetime1">
              <a:rPr lang="en-US" smtClean="0"/>
              <a:t>10/06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70BCB-D28B-0D41-940E-610F46AC215D}" type="datetime1">
              <a:rPr lang="en-US" smtClean="0"/>
              <a:t>10/06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FAF6-2056-A349-AD15-651E4A784E9B}" type="datetime1">
              <a:rPr lang="en-US" smtClean="0"/>
              <a:t>10/06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61A59-5B12-244A-9F14-FF71CEC702D4}" type="datetime1">
              <a:rPr lang="en-US" smtClean="0"/>
              <a:t>10/06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8219D-7BBE-9B44-A608-C49C920F2051}" type="datetime1">
              <a:rPr lang="en-US" smtClean="0"/>
              <a:t>10/06/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64ED-57D7-9B4F-92C0-55EA7EBA4992}" type="datetime1">
              <a:rPr lang="en-US" smtClean="0"/>
              <a:t>10/06/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E042D-0048-3B41-A68B-D978307965B7}" type="datetime1">
              <a:rPr lang="en-US" smtClean="0"/>
              <a:t>10/06/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28AA9-9DAF-924F-9AAF-2FF5B244A49F}" type="datetime1">
              <a:rPr lang="en-US" smtClean="0"/>
              <a:t>10/06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FDF8-2AC4-3E4E-A75D-B5FC246A2D13}" type="datetime1">
              <a:rPr lang="en-US" smtClean="0"/>
              <a:t>10/06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2053F-273C-BE44-B141-C49B48AD2A29}" type="datetime1">
              <a:rPr lang="en-US" smtClean="0"/>
              <a:t>10/06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96927" y="909745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fld id="{D21843A9-2B62-CA4D-9B36-735B3DBCFB3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843A9-2B62-CA4D-9B36-735B3DBCFB3A}" type="slidenum">
              <a:rPr lang="en-GB" smtClean="0"/>
              <a:pPr/>
              <a:t>80</a:t>
            </a:fld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505506" y="392667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/>
                <a:cs typeface="Arial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306993" y="1842726"/>
            <a:ext cx="6339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Sterile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bead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23658" y="1842726"/>
            <a:ext cx="9449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NH57388A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beads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242126" y="1086326"/>
            <a:ext cx="1236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IL-17F (pg/mL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5681" y="238674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/>
                <a:cs typeface="Arial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262301" y="3080399"/>
            <a:ext cx="1236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IL-21 (pg/mL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327168" y="3841106"/>
            <a:ext cx="6339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Sterile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bead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187479" y="3856154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NH57388A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beads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3477" y="402726"/>
            <a:ext cx="2064277" cy="14400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0317" y="2441365"/>
            <a:ext cx="2164364" cy="144000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587004" y="429839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/>
                <a:cs typeface="Arial"/>
              </a:rPr>
              <a:t>c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403109" y="5842900"/>
            <a:ext cx="7639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Sterile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bead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67074" y="5841256"/>
            <a:ext cx="997608" cy="401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NH57388A</a:t>
            </a:r>
          </a:p>
          <a:p>
            <a:pPr algn="ctr"/>
            <a:r>
              <a:rPr lang="en-GB" sz="1000" dirty="0" smtClean="0">
                <a:latin typeface="Arial"/>
                <a:cs typeface="Arial"/>
              </a:rPr>
              <a:t>beads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338242" y="5120904"/>
            <a:ext cx="1236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/>
                <a:cs typeface="Arial"/>
              </a:rPr>
              <a:t>IL-17A (pg/mL)</a:t>
            </a: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4624" y="4427245"/>
            <a:ext cx="2090057" cy="144000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587004" y="6468149"/>
            <a:ext cx="57000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+mj-lt"/>
              </a:rPr>
              <a:t>Supplementary </a:t>
            </a:r>
            <a:r>
              <a:rPr lang="en-US" sz="1200" b="1" dirty="0">
                <a:latin typeface="+mj-lt"/>
              </a:rPr>
              <a:t>Figure 1 – Levels of BAL and lung homogenate cytokines </a:t>
            </a:r>
            <a:r>
              <a:rPr lang="en-US" sz="1200" b="1" dirty="0" smtClean="0">
                <a:latin typeface="+mj-lt"/>
              </a:rPr>
              <a:t>in mice treated with sterile beads and </a:t>
            </a:r>
            <a:r>
              <a:rPr lang="en-US" sz="1200" b="1" i="1" dirty="0" smtClean="0">
                <a:latin typeface="+mj-lt"/>
              </a:rPr>
              <a:t>Pseudomonas </a:t>
            </a:r>
            <a:r>
              <a:rPr lang="en-US" sz="1200" b="1" i="1" dirty="0" err="1" smtClean="0">
                <a:latin typeface="+mj-lt"/>
              </a:rPr>
              <a:t>aeruginosa</a:t>
            </a:r>
            <a:r>
              <a:rPr lang="en-US" sz="1200" b="1" i="1" dirty="0" smtClean="0">
                <a:latin typeface="+mj-lt"/>
              </a:rPr>
              <a:t> </a:t>
            </a:r>
            <a:r>
              <a:rPr lang="en-US" sz="1200" b="1" dirty="0" smtClean="0">
                <a:latin typeface="+mj-lt"/>
              </a:rPr>
              <a:t>laden beads</a:t>
            </a:r>
          </a:p>
          <a:p>
            <a:endParaRPr lang="en-GB" sz="1200" dirty="0">
              <a:latin typeface="+mj-lt"/>
            </a:endParaRPr>
          </a:p>
          <a:p>
            <a:r>
              <a:rPr lang="en-US" sz="1200" dirty="0">
                <a:latin typeface="+mj-lt"/>
                <a:cs typeface="Arial"/>
              </a:rPr>
              <a:t>C57Bl6 mice were treated with intrapulmonary sterile agar beads or agar beads laden with </a:t>
            </a:r>
            <a:r>
              <a:rPr lang="en-US" sz="1200" i="1" dirty="0">
                <a:latin typeface="+mj-lt"/>
                <a:cs typeface="Arial"/>
              </a:rPr>
              <a:t>Pseudomonas </a:t>
            </a:r>
            <a:r>
              <a:rPr lang="en-US" sz="1200" i="1" dirty="0" err="1">
                <a:latin typeface="+mj-lt"/>
                <a:cs typeface="Arial"/>
              </a:rPr>
              <a:t>aeruginosa</a:t>
            </a:r>
            <a:r>
              <a:rPr lang="en-US" sz="1200" dirty="0">
                <a:latin typeface="+mj-lt"/>
                <a:cs typeface="Arial"/>
              </a:rPr>
              <a:t> strain NH57388A. BAL IL-17F (a), BAL IL-21 (b) and lung homogenate IL-17A levels measured at 2-weeks post-instillation of sterile agar beads or beads laden with NH57388A. Line represents median. P-values denote comparison by Mann-Whitney test. </a:t>
            </a:r>
            <a:r>
              <a:rPr lang="en-GB" sz="1200" dirty="0" smtClean="0">
                <a:latin typeface="+mj-lt"/>
                <a:cs typeface="Arial"/>
              </a:rPr>
              <a:t>. </a:t>
            </a:r>
            <a:r>
              <a:rPr lang="en-GB" sz="1200" dirty="0" smtClean="0">
                <a:solidFill>
                  <a:srgbClr val="FF0000"/>
                </a:solidFill>
                <a:latin typeface="+mj-lt"/>
                <a:ea typeface="Zapf Dingbats"/>
                <a:cs typeface="Arial"/>
                <a:sym typeface="Zapf Dingbats"/>
              </a:rPr>
              <a:t>★</a:t>
            </a:r>
            <a:r>
              <a:rPr lang="en-GB" sz="1200" dirty="0" smtClean="0">
                <a:latin typeface="+mj-lt"/>
                <a:cs typeface="Arial"/>
              </a:rPr>
              <a:t>, animals with on-going pulmonary PA infection</a:t>
            </a:r>
            <a:r>
              <a:rPr lang="en-GB" sz="1200" dirty="0" smtClean="0">
                <a:latin typeface="Arial"/>
                <a:cs typeface="Arial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273036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62</TotalTime>
  <Words>148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lum Bain</dc:creator>
  <cp:lastModifiedBy>Hannah Bayes</cp:lastModifiedBy>
  <cp:revision>243</cp:revision>
  <cp:lastPrinted>2012-05-31T15:58:57Z</cp:lastPrinted>
  <dcterms:created xsi:type="dcterms:W3CDTF">2012-05-31T15:57:20Z</dcterms:created>
  <dcterms:modified xsi:type="dcterms:W3CDTF">2016-06-10T06:40:58Z</dcterms:modified>
</cp:coreProperties>
</file>